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94034-3BCD-442E-9A30-CA8D74465F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7E5879-9EF4-4DB9-884D-49E0F2D5BC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0F4139-C127-42F1-BF45-B87874FB559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F5133-83DD-4AAC-838D-3CD9AC6B8EE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E1B6A8-C3DD-4BBB-B3F0-2CDFE842D6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345E7-F048-42CA-939D-15DCB3F4A6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59C7C-19D5-440B-B352-AA3C392BF80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8D9FD-7229-4EC6-94D2-6A0E36C8D8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45B12-FD31-4965-B90A-925FE7DB24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BD981C-2A2A-4954-81B1-7E40567633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0091A0-A533-46D6-83CE-BA402CD0F63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9A3CB0-E54B-4CAE-8017-78F6CE9CAD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C2F875-3C0B-4929-96A3-72C8E0FC09F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80880" y="3960000"/>
            <a:ext cx="609624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igure S4.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A graphical representation of overlapping molecular and cellular functions for SMAD-responsive and SMAD-target genes sorted by statistical significance. The statistical significance of each function was calculated by Fischer’s exact test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tretch/>
        </p:blipFill>
        <p:spPr>
          <a:xfrm>
            <a:off x="76320" y="1600200"/>
            <a:ext cx="6781680" cy="1562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6-19T14:31:36Z</dcterms:created>
  <dc:creator>Huaxia Qin</dc:creator>
  <dc:description/>
  <dc:language>en-US</dc:language>
  <cp:lastModifiedBy>Ramana Davuluri</cp:lastModifiedBy>
  <dcterms:modified xsi:type="dcterms:W3CDTF">2008-12-10T17:45:43Z</dcterms:modified>
  <cp:revision>34</cp:revision>
  <dc:subject/>
  <dc:title>Slide 1</dc:title>
</cp:coreProperties>
</file>